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7" r:id="rId2"/>
  </p:sldIdLst>
  <p:sldSz cx="12192000" cy="6858000"/>
  <p:notesSz cx="7010400" cy="9236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6014" autoAdjust="0"/>
    <p:restoredTop sz="93447" autoAdjust="0"/>
  </p:normalViewPr>
  <p:slideViewPr>
    <p:cSldViewPr snapToGrid="0">
      <p:cViewPr varScale="1">
        <p:scale>
          <a:sx n="107" d="100"/>
          <a:sy n="107" d="100"/>
        </p:scale>
        <p:origin x="120" y="1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340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340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5878891-3B70-4B94-BAEE-88FEB18586E5}" type="datetimeFigureOut">
              <a:rPr lang="en-US" smtClean="0"/>
              <a:t>10/21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35013" y="1154113"/>
            <a:ext cx="5540375" cy="31162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44861"/>
            <a:ext cx="5608320" cy="363670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772669"/>
            <a:ext cx="3037840" cy="46340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772669"/>
            <a:ext cx="3037840" cy="46340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897DE3F-8F04-476B-AF8E-D0D1D2CF36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93762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EFAB3D3-B251-344A-8382-653C787FD62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8569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DECF64-62E6-4B8E-90D5-84029C0D69A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EFC55DB-270A-FE06-C0C2-8C3B7960E0B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36E5E1-EFE0-D916-EE58-848BFE985C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D2AE-1854-4865-8E28-7F0D0DB748FF}" type="datetimeFigureOut">
              <a:rPr lang="en-US" smtClean="0"/>
              <a:t>10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624415-F5A9-5098-5E2E-9C05872486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45B319-3B47-4B86-1939-2395AC0E0B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1D2E-E029-4622-A508-9B9C13E1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60702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A48B98-5F78-5FAE-F487-932D8CDB55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0050F19-B690-1C98-4C97-C2EB7016593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47D955-E84D-DA92-71E0-19983DE7EE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D2AE-1854-4865-8E28-7F0D0DB748FF}" type="datetimeFigureOut">
              <a:rPr lang="en-US" smtClean="0"/>
              <a:t>10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EE7442-0FA0-0662-4880-EB70B5A386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A60A8C-DACC-C25D-EA31-2286374737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1D2E-E029-4622-A508-9B9C13E1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14730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AFAA582-80EA-8FFE-6717-8F7660FD224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006AB09-1D1B-598A-3196-87DE1F9B810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1D5950-191C-D2E6-3974-A35C46151C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D2AE-1854-4865-8E28-7F0D0DB748FF}" type="datetimeFigureOut">
              <a:rPr lang="en-US" smtClean="0"/>
              <a:t>10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E24EE5-9452-84DF-1A7F-3D2E1C52CE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4FCC4B-8E7D-2B5D-0791-B950B76224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1D2E-E029-4622-A508-9B9C13E1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36992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7103AE-2CA8-D316-AFE5-E63ABEA098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4C24A61-629B-67A4-921D-8E595D3372D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1DC599-085D-F352-6523-1CE8CB325E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D2AE-1854-4865-8E28-7F0D0DB748FF}" type="datetimeFigureOut">
              <a:rPr lang="en-US" smtClean="0"/>
              <a:t>10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056BCE-8FDD-DC7C-BFA2-646FCFD7F6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0E68B1-7026-6D9A-AA6F-86D5A2244A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1D2E-E029-4622-A508-9B9C13E1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47007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1159DE-46C7-7112-D8F4-AC0846F4D4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C751615-850B-8EE3-CD07-A41BCC96B0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6D6D35-6EEE-76CB-A7B3-9393C6285B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D2AE-1854-4865-8E28-7F0D0DB748FF}" type="datetimeFigureOut">
              <a:rPr lang="en-US" smtClean="0"/>
              <a:t>10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E1BD30-B32D-92E3-8943-51DD5C0056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903268-9725-9EEB-4396-3DC7FE27B9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1D2E-E029-4622-A508-9B9C13E1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20644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8EA0BF-849F-9564-DDCD-9D6E2F52E8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9B608DA-F013-88F9-DECC-12F3D99742B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1B9CD44-76E8-EB8B-4F78-D717428AF94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3A4DA9-3BC5-6799-6BA0-C4C1991711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D2AE-1854-4865-8E28-7F0D0DB748FF}" type="datetimeFigureOut">
              <a:rPr lang="en-US" smtClean="0"/>
              <a:t>10/2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050E6D9-1A18-C6B4-92F5-CFF5A6A408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AA9BB7A-3135-2BF6-6401-D24789835F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1D2E-E029-4622-A508-9B9C13E1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28245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2FAC7F-C16F-D8C4-3D2E-AD085291B3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1FF2890-2C17-37FD-0A84-F3892166DD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305EA2C-667E-3AB7-E26B-8A78C667B47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9F41096-C25D-2831-01D7-2D3B934545D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F951FEE-E9E0-6A8E-CE16-01F17AD753B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F5F7DA7-B82C-D8DB-4CB6-A2EBB76DAB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D2AE-1854-4865-8E28-7F0D0DB748FF}" type="datetimeFigureOut">
              <a:rPr lang="en-US" smtClean="0"/>
              <a:t>10/21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4914E22-4792-AF32-96EE-BA1F85350A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312D419-4CC5-FE70-6BE4-A530667D1F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1D2E-E029-4622-A508-9B9C13E1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9925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66F74C-1488-E29C-0EF7-29815B736E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A1B1ADC-5E07-A38D-9B4D-54BDEEA376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D2AE-1854-4865-8E28-7F0D0DB748FF}" type="datetimeFigureOut">
              <a:rPr lang="en-US" smtClean="0"/>
              <a:t>10/21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FD3A60B-1623-0F7E-17FA-23C909281C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73969C3-F1A5-90A5-D54E-E6258A2D44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1D2E-E029-4622-A508-9B9C13E1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66122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51E7637-6E7A-283C-6283-60359DF8E8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D2AE-1854-4865-8E28-7F0D0DB748FF}" type="datetimeFigureOut">
              <a:rPr lang="en-US" smtClean="0"/>
              <a:t>10/21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7E4978E-B117-9941-29EC-A70E0FA980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3FD7E27-B98F-6776-573A-EBACEC9A48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1D2E-E029-4622-A508-9B9C13E1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07929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CDCCCB-1A48-3A52-BAE1-BFED42D545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2934DA0-DFB0-DE2B-9DD5-A6E08348ADA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925438A-98D3-6F12-5556-FD99DD44892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5FD4AED-5D58-CA1B-FD3F-15506906C2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D2AE-1854-4865-8E28-7F0D0DB748FF}" type="datetimeFigureOut">
              <a:rPr lang="en-US" smtClean="0"/>
              <a:t>10/2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79CB4F1-064F-7EE5-ECD7-3AF1818204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16C0817-EA96-463A-7FC5-0238C772BE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1D2E-E029-4622-A508-9B9C13E1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24982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25C869-05BF-9F9A-18D3-0662AB90AA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0CA6735-F013-975D-91C3-36205A93832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7843637-448B-0412-ED75-BFAC61BA7F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5EF5FAF-7C11-BCAF-C5F7-9DB8DF122A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D2AE-1854-4865-8E28-7F0D0DB748FF}" type="datetimeFigureOut">
              <a:rPr lang="en-US" smtClean="0"/>
              <a:t>10/2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3637007-F46F-052B-F5EC-2C05A50B96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39C9CED-02A8-286D-37DD-8F866DB231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1D2E-E029-4622-A508-9B9C13E1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48315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D47AEBF-16CF-0A62-F011-6A11A4E998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401EB9A-1BFA-5855-3D70-BBE95E170F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F12A36-4D3F-6E80-E41F-79314E92005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00D2AE-1854-4865-8E28-7F0D0DB748FF}" type="datetimeFigureOut">
              <a:rPr lang="en-US" smtClean="0"/>
              <a:t>10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249328-9A8E-A056-517B-F9FD5B9D882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80532B-B214-6D1B-94CE-81305ED7ABA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881D2E-E029-4622-A508-9B9C13E1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02333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A graph of a number of graphs&#10;&#10;Description automatically generated">
            <a:extLst>
              <a:ext uri="{FF2B5EF4-FFF2-40B4-BE49-F238E27FC236}">
                <a16:creationId xmlns:a16="http://schemas.microsoft.com/office/drawing/2014/main" id="{323C696F-A4BC-E345-8C84-5BAA571319A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462"/>
          <a:stretch/>
        </p:blipFill>
        <p:spPr>
          <a:xfrm>
            <a:off x="2678872" y="27817"/>
            <a:ext cx="8744044" cy="2218439"/>
          </a:xfrm>
          <a:prstGeom prst="rect">
            <a:avLst/>
          </a:prstGeom>
        </p:spPr>
      </p:pic>
      <p:pic>
        <p:nvPicPr>
          <p:cNvPr id="9" name="Picture 8" descr="A graph of a number of different colored lines&#10;&#10;Description automatically generated with medium confidence">
            <a:extLst>
              <a:ext uri="{FF2B5EF4-FFF2-40B4-BE49-F238E27FC236}">
                <a16:creationId xmlns:a16="http://schemas.microsoft.com/office/drawing/2014/main" id="{01ABC586-3FAC-E189-C53F-E9588F0FFB1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31647"/>
          <a:stretch/>
        </p:blipFill>
        <p:spPr>
          <a:xfrm>
            <a:off x="5504419" y="1919759"/>
            <a:ext cx="1752268" cy="1602236"/>
          </a:xfrm>
          <a:prstGeom prst="rect">
            <a:avLst/>
          </a:prstGeom>
        </p:spPr>
      </p:pic>
      <p:pic>
        <p:nvPicPr>
          <p:cNvPr id="13" name="Picture 12" descr="A graph of a number of cells&#10;&#10;Description automatically generated">
            <a:extLst>
              <a:ext uri="{FF2B5EF4-FFF2-40B4-BE49-F238E27FC236}">
                <a16:creationId xmlns:a16="http://schemas.microsoft.com/office/drawing/2014/main" id="{523D9118-9F7F-D442-3E0E-9B98F5E9324B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31891"/>
          <a:stretch/>
        </p:blipFill>
        <p:spPr>
          <a:xfrm>
            <a:off x="3643319" y="1919759"/>
            <a:ext cx="1746027" cy="1602236"/>
          </a:xfrm>
          <a:prstGeom prst="rect">
            <a:avLst/>
          </a:prstGeom>
        </p:spPr>
      </p:pic>
      <p:pic>
        <p:nvPicPr>
          <p:cNvPr id="15" name="Picture 14" descr="A graph with numbers and lines&#10;&#10;Description automatically generated with medium confidence">
            <a:extLst>
              <a:ext uri="{FF2B5EF4-FFF2-40B4-BE49-F238E27FC236}">
                <a16:creationId xmlns:a16="http://schemas.microsoft.com/office/drawing/2014/main" id="{7E9BE34C-9D0A-7440-F8DD-6346B933F60E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r="31240"/>
          <a:stretch/>
        </p:blipFill>
        <p:spPr>
          <a:xfrm>
            <a:off x="7340221" y="1919821"/>
            <a:ext cx="1762566" cy="1602111"/>
          </a:xfrm>
          <a:prstGeom prst="rect">
            <a:avLst/>
          </a:prstGeom>
        </p:spPr>
      </p:pic>
      <p:pic>
        <p:nvPicPr>
          <p:cNvPr id="17" name="Picture 16" descr="A graph of progress of a number of schematic lines&#10;&#10;Description automatically generated with medium confidence">
            <a:extLst>
              <a:ext uri="{FF2B5EF4-FFF2-40B4-BE49-F238E27FC236}">
                <a16:creationId xmlns:a16="http://schemas.microsoft.com/office/drawing/2014/main" id="{7B8E3725-B95D-D014-D835-24A58047C254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r="31215"/>
          <a:stretch/>
        </p:blipFill>
        <p:spPr>
          <a:xfrm>
            <a:off x="9123952" y="1925308"/>
            <a:ext cx="1751138" cy="1591138"/>
          </a:xfrm>
          <a:prstGeom prst="rect">
            <a:avLst/>
          </a:prstGeom>
        </p:spPr>
      </p:pic>
      <p:pic>
        <p:nvPicPr>
          <p:cNvPr id="19" name="Picture 18" descr="A graph of cancer patients&#10;&#10;Description automatically generated">
            <a:extLst>
              <a:ext uri="{FF2B5EF4-FFF2-40B4-BE49-F238E27FC236}">
                <a16:creationId xmlns:a16="http://schemas.microsoft.com/office/drawing/2014/main" id="{4AB1F583-1217-C711-0729-A37B59F566ED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r="31809"/>
          <a:stretch/>
        </p:blipFill>
        <p:spPr>
          <a:xfrm>
            <a:off x="3642336" y="3647788"/>
            <a:ext cx="1747994" cy="1602111"/>
          </a:xfrm>
          <a:prstGeom prst="rect">
            <a:avLst/>
          </a:prstGeom>
        </p:spPr>
      </p:pic>
      <p:pic>
        <p:nvPicPr>
          <p:cNvPr id="21" name="Picture 20" descr="A graph of progress of a number of schematic models&#10;&#10;Description automatically generated with medium confidence">
            <a:extLst>
              <a:ext uri="{FF2B5EF4-FFF2-40B4-BE49-F238E27FC236}">
                <a16:creationId xmlns:a16="http://schemas.microsoft.com/office/drawing/2014/main" id="{BC8CDB7E-3530-13F4-6B67-164992BE2390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r="30622"/>
          <a:stretch/>
        </p:blipFill>
        <p:spPr>
          <a:xfrm>
            <a:off x="5491348" y="3647788"/>
            <a:ext cx="1778410" cy="1602111"/>
          </a:xfrm>
          <a:prstGeom prst="rect">
            <a:avLst/>
          </a:prstGeom>
        </p:spPr>
      </p:pic>
      <p:pic>
        <p:nvPicPr>
          <p:cNvPr id="23" name="Picture 22" descr="A graph of a number of sclerosis&#10;&#10;Description automatically generated with medium confidence">
            <a:extLst>
              <a:ext uri="{FF2B5EF4-FFF2-40B4-BE49-F238E27FC236}">
                <a16:creationId xmlns:a16="http://schemas.microsoft.com/office/drawing/2014/main" id="{C2413D4C-75B2-909C-44BF-8AC5085561CD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r="31951"/>
          <a:stretch/>
        </p:blipFill>
        <p:spPr>
          <a:xfrm>
            <a:off x="7347507" y="3646120"/>
            <a:ext cx="1747994" cy="1605446"/>
          </a:xfrm>
          <a:prstGeom prst="rect">
            <a:avLst/>
          </a:prstGeom>
        </p:spPr>
      </p:pic>
      <p:pic>
        <p:nvPicPr>
          <p:cNvPr id="25" name="Picture 24" descr="A graph of a number of cells&#10;&#10;Description automatically generated">
            <a:extLst>
              <a:ext uri="{FF2B5EF4-FFF2-40B4-BE49-F238E27FC236}">
                <a16:creationId xmlns:a16="http://schemas.microsoft.com/office/drawing/2014/main" id="{D5B7A481-D2EE-C4CA-A5FD-51C31680CFDE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r="32017"/>
          <a:stretch/>
        </p:blipFill>
        <p:spPr>
          <a:xfrm>
            <a:off x="9121682" y="3641798"/>
            <a:ext cx="1755678" cy="1614091"/>
          </a:xfrm>
          <a:prstGeom prst="rect">
            <a:avLst/>
          </a:prstGeom>
        </p:spPr>
      </p:pic>
      <p:pic>
        <p:nvPicPr>
          <p:cNvPr id="27" name="Picture 26" descr="A graph of progress and time&#10;&#10;Description automatically generated with medium confidence">
            <a:extLst>
              <a:ext uri="{FF2B5EF4-FFF2-40B4-BE49-F238E27FC236}">
                <a16:creationId xmlns:a16="http://schemas.microsoft.com/office/drawing/2014/main" id="{064795E6-B23F-5BE3-2EBB-5356D1168099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r="31998"/>
          <a:stretch/>
        </p:blipFill>
        <p:spPr>
          <a:xfrm>
            <a:off x="3644759" y="5253297"/>
            <a:ext cx="1743148" cy="1602111"/>
          </a:xfrm>
          <a:prstGeom prst="rect">
            <a:avLst/>
          </a:prstGeom>
        </p:spPr>
      </p:pic>
      <p:pic>
        <p:nvPicPr>
          <p:cNvPr id="29" name="Picture 28" descr="A graph with different colored lines&#10;&#10;Description automatically generated">
            <a:extLst>
              <a:ext uri="{FF2B5EF4-FFF2-40B4-BE49-F238E27FC236}">
                <a16:creationId xmlns:a16="http://schemas.microsoft.com/office/drawing/2014/main" id="{5FC054F6-8961-BF78-2DF2-AAD3C7E6DFC3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r="31290"/>
          <a:stretch/>
        </p:blipFill>
        <p:spPr>
          <a:xfrm>
            <a:off x="5499912" y="5253297"/>
            <a:ext cx="1761282" cy="1602111"/>
          </a:xfrm>
          <a:prstGeom prst="rect">
            <a:avLst/>
          </a:prstGeom>
        </p:spPr>
      </p:pic>
      <p:pic>
        <p:nvPicPr>
          <p:cNvPr id="31" name="Picture 30" descr="A graph of a number of sclerosis&#10;&#10;Description automatically generated with medium confidence">
            <a:extLst>
              <a:ext uri="{FF2B5EF4-FFF2-40B4-BE49-F238E27FC236}">
                <a16:creationId xmlns:a16="http://schemas.microsoft.com/office/drawing/2014/main" id="{D0FD607A-E8EC-1B59-A8E1-B091DF60A63C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r="-1357"/>
          <a:stretch/>
        </p:blipFill>
        <p:spPr>
          <a:xfrm>
            <a:off x="9116347" y="5253297"/>
            <a:ext cx="2598164" cy="1602111"/>
          </a:xfrm>
          <a:prstGeom prst="rect">
            <a:avLst/>
          </a:prstGeom>
        </p:spPr>
      </p:pic>
      <p:pic>
        <p:nvPicPr>
          <p:cNvPr id="33" name="Picture 32" descr="A graph of a number of different colored lines&#10;&#10;Description automatically generated with medium confidence">
            <a:extLst>
              <a:ext uri="{FF2B5EF4-FFF2-40B4-BE49-F238E27FC236}">
                <a16:creationId xmlns:a16="http://schemas.microsoft.com/office/drawing/2014/main" id="{F58033AE-F766-3EA8-24B4-F91A99E503B9}"/>
              </a:ext>
            </a:extLst>
          </p:cNvPr>
          <p:cNvPicPr>
            <a:picLocks noChangeAspect="1"/>
          </p:cNvPicPr>
          <p:nvPr/>
        </p:nvPicPr>
        <p:blipFill rotWithShape="1">
          <a:blip r:embed="rId15"/>
          <a:srcRect r="30758"/>
          <a:stretch/>
        </p:blipFill>
        <p:spPr>
          <a:xfrm>
            <a:off x="7334043" y="5253297"/>
            <a:ext cx="1774924" cy="160211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CAE331FC-69C1-29C5-917D-CA8EE54B6DAC}"/>
              </a:ext>
            </a:extLst>
          </p:cNvPr>
          <p:cNvSpPr txBox="1"/>
          <p:nvPr/>
        </p:nvSpPr>
        <p:spPr>
          <a:xfrm>
            <a:off x="1988009" y="122523"/>
            <a:ext cx="5273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04D4B51-C60C-F537-F86B-026ADEE25AD0}"/>
              </a:ext>
            </a:extLst>
          </p:cNvPr>
          <p:cNvSpPr txBox="1"/>
          <p:nvPr/>
        </p:nvSpPr>
        <p:spPr>
          <a:xfrm>
            <a:off x="2055164" y="1919759"/>
            <a:ext cx="5273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FFB9679-7BEC-AAD0-8F61-F2607604BA31}"/>
              </a:ext>
            </a:extLst>
          </p:cNvPr>
          <p:cNvSpPr txBox="1"/>
          <p:nvPr/>
        </p:nvSpPr>
        <p:spPr>
          <a:xfrm>
            <a:off x="143435" y="122523"/>
            <a:ext cx="1748118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Figure 6. Prognostic transcriptional signatures stratified by TP53 mutation and BC360 HRD expression status in solid tissues.</a:t>
            </a:r>
            <a:r>
              <a:rPr lang="en-US" sz="9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A) Hazard ratios of prognostic BC360 Signatures stratified by TP53 status and gene expression signature score. Red points indicate significantly associated with PFS (log-rank p &lt; 0.05).  B) Kaplan-Meier plot of signatures associated with PFS stratified by TP53 and gene expression level. Dark blue= Low HDR/No TP53 variant; Light Blue=Low HRD/TP53 variant; Orange=High HRD/No TP53 variant; Red=High HRD/TP53 variant.</a:t>
            </a:r>
            <a:endParaRPr lang="en-US" sz="9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428279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849</TotalTime>
  <Words>107</Words>
  <Application>Microsoft Office PowerPoint</Application>
  <PresentationFormat>Widescreen</PresentationFormat>
  <Paragraphs>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ne Bayani</dc:creator>
  <cp:lastModifiedBy>Quann, Karen</cp:lastModifiedBy>
  <cp:revision>308</cp:revision>
  <cp:lastPrinted>2023-08-16T18:12:39Z</cp:lastPrinted>
  <dcterms:created xsi:type="dcterms:W3CDTF">2023-05-04T15:52:47Z</dcterms:created>
  <dcterms:modified xsi:type="dcterms:W3CDTF">2025-10-21T17:20:23Z</dcterms:modified>
</cp:coreProperties>
</file>